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jpeg" ContentType="image/jpeg"/>
  <Override PartName="/ppt/media/image3.png" ContentType="image/png"/>
  <Override PartName="/ppt/media/image4.png" ContentType="image/pn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6858000" cy="9907588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2241720" y="685440"/>
            <a:ext cx="2374560" cy="34290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NZ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965FA9DA-6FBC-44F7-8B69-A7F908D5B583}" type="slidenum">
              <a:rPr b="0" lang="en-NZ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9" name="PlaceHolder 1"/>
          <p:cNvSpPr>
            <a:spLocks noGrp="1"/>
          </p:cNvSpPr>
          <p:nvPr>
            <p:ph type="sldImg"/>
          </p:nvPr>
        </p:nvSpPr>
        <p:spPr>
          <a:xfrm>
            <a:off x="2241720" y="685800"/>
            <a:ext cx="2374560" cy="3429000"/>
          </a:xfrm>
          <a:prstGeom prst="rect">
            <a:avLst/>
          </a:prstGeom>
          <a:ln w="0">
            <a:noFill/>
          </a:ln>
        </p:spPr>
      </p:sp>
      <p:sp>
        <p:nvSpPr>
          <p:cNvPr id="140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1" name="Slide Number Placeholder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D32AD979-A067-490C-A16F-62CEFA93F7BC}" type="slidenum">
              <a:rPr b="0" lang="en-NZ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2ED8913-AB94-439A-986D-9AA83E81DAFF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50FDE4A-908D-4908-A8E4-BF379CBC09D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5669840-15CB-4B3D-8A66-31BE9172EFA3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0B51D44-0A61-40B3-8821-B88AC8209739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34078FF-9F8D-4081-B256-3F15229641A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FDEDAD3-9433-4775-8EE4-A1FCA5A2BD8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7988D52-7A6A-4283-9E89-10A5384210A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D9EAFB8-A9D0-4EE5-ABA0-CF8A1BE594E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96360"/>
            <a:ext cx="6172200" cy="76557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1875C5E-E31C-439E-AC5D-B3D88894F89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6EE8509-207B-485E-BC60-A35F08E7AF4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96E7CF9-A513-4446-BCD4-67DAAF762D4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AD78C70-D1B5-4F38-88B2-8462233DF91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9182160"/>
            <a:ext cx="160020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9182160"/>
            <a:ext cx="217152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9182160"/>
            <a:ext cx="160020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NZ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188C42F6-E08B-4B14-A8AE-628A79EC07A0}" type="slidenum">
              <a:rPr b="0" lang="en-NZ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jpe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slideLayout" Target="../slideLayouts/slideLayout1.xml"/><Relationship Id="rId6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TextBox 38"/>
          <p:cNvSpPr/>
          <p:nvPr/>
        </p:nvSpPr>
        <p:spPr>
          <a:xfrm>
            <a:off x="291960" y="426960"/>
            <a:ext cx="157176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NZ" sz="1100" spc="-1" strike="noStrike">
                <a:solidFill>
                  <a:srgbClr val="000000"/>
                </a:solidFill>
                <a:latin typeface="Arial"/>
                <a:ea typeface="Arial"/>
              </a:rPr>
              <a:t>Overall Survival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Rectangle 80"/>
          <p:cNvSpPr/>
          <p:nvPr/>
        </p:nvSpPr>
        <p:spPr>
          <a:xfrm>
            <a:off x="189000" y="7783560"/>
            <a:ext cx="6453000" cy="1554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NZ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dditional file 5: </a:t>
            </a:r>
            <a:r>
              <a:rPr b="0" lang="en-NZ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ssociation of tumor ARTEMIN (ARTN) and TWIST1 expression with overall survival outcome in ER-MC.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NZ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</a:t>
            </a:r>
            <a:r>
              <a:rPr b="0" lang="en-NZ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Kaplan-Meier analysis of the association of ARTN expression (I), TWIST1 expression (II), low-ARTN and low-TWIST1 vs high ARTN expression and low-TWIST1 expression (III) and with low-ARTN and low-TWIST1 vs high ARTN expression and high TWIST1 expression (IV) overall survival (OS) in ER-MC patients. The OS rate significantly decreased  with either  high TWIST1, high-ARTN and low-TWIST1or with high-ARTN and high-TWIST1 expression (II-IV)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TextBox 36"/>
          <p:cNvSpPr/>
          <p:nvPr/>
        </p:nvSpPr>
        <p:spPr>
          <a:xfrm>
            <a:off x="4624560" y="2975040"/>
            <a:ext cx="8632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NZ" sz="1000" spc="-1" strike="noStrike">
                <a:solidFill>
                  <a:srgbClr val="000000"/>
                </a:solidFill>
                <a:latin typeface="Arial"/>
                <a:ea typeface="Arial"/>
              </a:rPr>
              <a:t>Months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1" name="Picture 4" descr=""/>
          <p:cNvPicPr/>
          <p:nvPr/>
        </p:nvPicPr>
        <p:blipFill>
          <a:blip r:embed="rId1"/>
          <a:stretch/>
        </p:blipFill>
        <p:spPr>
          <a:xfrm>
            <a:off x="762120" y="849240"/>
            <a:ext cx="2450880" cy="2073240"/>
          </a:xfrm>
          <a:prstGeom prst="rect">
            <a:avLst/>
          </a:prstGeom>
          <a:ln w="0">
            <a:noFill/>
          </a:ln>
        </p:spPr>
      </p:pic>
      <p:sp>
        <p:nvSpPr>
          <p:cNvPr id="52" name="Text Box 7"/>
          <p:cNvSpPr/>
          <p:nvPr/>
        </p:nvSpPr>
        <p:spPr>
          <a:xfrm>
            <a:off x="1230840" y="2295360"/>
            <a:ext cx="8222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NZ" sz="1000" spc="-1" strike="noStrike">
                <a:solidFill>
                  <a:srgbClr val="000000"/>
                </a:solidFill>
                <a:latin typeface="Arial"/>
              </a:rPr>
              <a:t>Low ARTN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Text Box 9"/>
          <p:cNvSpPr/>
          <p:nvPr/>
        </p:nvSpPr>
        <p:spPr>
          <a:xfrm>
            <a:off x="1231560" y="2440080"/>
            <a:ext cx="8496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宋体"/>
              </a:rPr>
              <a:t>High ARTN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Text Box 10"/>
          <p:cNvSpPr/>
          <p:nvPr/>
        </p:nvSpPr>
        <p:spPr>
          <a:xfrm>
            <a:off x="999720" y="2617920"/>
            <a:ext cx="6534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000" spc="-1" strike="noStrike">
                <a:solidFill>
                  <a:srgbClr val="000000"/>
                </a:solidFill>
                <a:latin typeface="Arial"/>
                <a:ea typeface="宋体"/>
              </a:rPr>
              <a:t>P</a:t>
            </a: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宋体"/>
              </a:rPr>
              <a:t> = 0.13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55" name="Group 225"/>
          <p:cNvGrpSpPr/>
          <p:nvPr/>
        </p:nvGrpSpPr>
        <p:grpSpPr>
          <a:xfrm>
            <a:off x="339840" y="287280"/>
            <a:ext cx="2922480" cy="2800440"/>
            <a:chOff x="339840" y="287280"/>
            <a:chExt cx="2922480" cy="2800440"/>
          </a:xfrm>
        </p:grpSpPr>
        <p:sp>
          <p:nvSpPr>
            <p:cNvPr id="56" name="Text Box 5"/>
            <p:cNvSpPr/>
            <p:nvPr/>
          </p:nvSpPr>
          <p:spPr>
            <a:xfrm flipV="1">
              <a:off x="339840" y="287280"/>
              <a:ext cx="332640" cy="2260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 vert="eaVer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NZ" sz="1000" spc="-1" strike="noStrike">
                  <a:solidFill>
                    <a:srgbClr val="000000"/>
                  </a:solidFill>
                  <a:latin typeface="Arial"/>
                </a:rPr>
                <a:t>Cumulative</a:t>
              </a: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宋体"/>
                </a:rPr>
                <a:t> survival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" name="Text Box 11"/>
            <p:cNvSpPr/>
            <p:nvPr/>
          </p:nvSpPr>
          <p:spPr>
            <a:xfrm>
              <a:off x="1214280" y="2841480"/>
              <a:ext cx="3207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宋体"/>
                </a:rPr>
                <a:t>3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" name="Text Box 12"/>
            <p:cNvSpPr/>
            <p:nvPr/>
          </p:nvSpPr>
          <p:spPr>
            <a:xfrm>
              <a:off x="1614600" y="2841480"/>
              <a:ext cx="4903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宋体"/>
                </a:rPr>
                <a:t>4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" name="Text Box 13"/>
            <p:cNvSpPr/>
            <p:nvPr/>
          </p:nvSpPr>
          <p:spPr>
            <a:xfrm>
              <a:off x="2027520" y="2836440"/>
              <a:ext cx="4996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宋体"/>
                </a:rPr>
                <a:t>5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" name="Text Box 14"/>
            <p:cNvSpPr/>
            <p:nvPr/>
          </p:nvSpPr>
          <p:spPr>
            <a:xfrm>
              <a:off x="2430720" y="2826720"/>
              <a:ext cx="4996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宋体"/>
                </a:rPr>
                <a:t>6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" name="Text Box 15"/>
            <p:cNvSpPr/>
            <p:nvPr/>
          </p:nvSpPr>
          <p:spPr>
            <a:xfrm>
              <a:off x="2833920" y="2836440"/>
              <a:ext cx="4284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宋体"/>
                </a:rPr>
                <a:t>7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" name="Text Box 16"/>
            <p:cNvSpPr/>
            <p:nvPr/>
          </p:nvSpPr>
          <p:spPr>
            <a:xfrm>
              <a:off x="635400" y="2610720"/>
              <a:ext cx="2509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宋体"/>
                </a:rPr>
                <a:t>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" name="Text Box 17"/>
            <p:cNvSpPr/>
            <p:nvPr/>
          </p:nvSpPr>
          <p:spPr>
            <a:xfrm>
              <a:off x="535320" y="2269800"/>
              <a:ext cx="3560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宋体"/>
                </a:rPr>
                <a:t>0.2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" name="Text Box 18"/>
            <p:cNvSpPr/>
            <p:nvPr/>
          </p:nvSpPr>
          <p:spPr>
            <a:xfrm>
              <a:off x="529920" y="1924560"/>
              <a:ext cx="3560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宋体"/>
                </a:rPr>
                <a:t>0.4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" name="Text Box 19"/>
            <p:cNvSpPr/>
            <p:nvPr/>
          </p:nvSpPr>
          <p:spPr>
            <a:xfrm>
              <a:off x="532800" y="1568520"/>
              <a:ext cx="3560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宋体"/>
                </a:rPr>
                <a:t>0.6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" name="Text Box 20"/>
            <p:cNvSpPr/>
            <p:nvPr/>
          </p:nvSpPr>
          <p:spPr>
            <a:xfrm>
              <a:off x="532800" y="1227600"/>
              <a:ext cx="3560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宋体"/>
                </a:rPr>
                <a:t>0.8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" name="Text Box 21"/>
            <p:cNvSpPr/>
            <p:nvPr/>
          </p:nvSpPr>
          <p:spPr>
            <a:xfrm>
              <a:off x="529920" y="905400"/>
              <a:ext cx="3560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宋体"/>
                </a:rPr>
                <a:t>1.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" name="Text Box 22"/>
            <p:cNvSpPr/>
            <p:nvPr/>
          </p:nvSpPr>
          <p:spPr>
            <a:xfrm>
              <a:off x="815040" y="2832120"/>
              <a:ext cx="3207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宋体"/>
                </a:rPr>
                <a:t>2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69" name="Text Box 37"/>
          <p:cNvSpPr/>
          <p:nvPr/>
        </p:nvSpPr>
        <p:spPr>
          <a:xfrm>
            <a:off x="2904480" y="2575080"/>
            <a:ext cx="2156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宋体"/>
              </a:rPr>
              <a:t>I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Straight Connector 216"/>
          <p:cNvSpPr/>
          <p:nvPr/>
        </p:nvSpPr>
        <p:spPr>
          <a:xfrm>
            <a:off x="1133640" y="2567160"/>
            <a:ext cx="144360" cy="0"/>
          </a:xfrm>
          <a:prstGeom prst="line">
            <a:avLst/>
          </a:prstGeom>
          <a:ln w="28440">
            <a:solidFill>
              <a:srgbClr val="4a7ebb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Straight Connector 217"/>
          <p:cNvSpPr/>
          <p:nvPr/>
        </p:nvSpPr>
        <p:spPr>
          <a:xfrm>
            <a:off x="1133640" y="2422440"/>
            <a:ext cx="144360" cy="0"/>
          </a:xfrm>
          <a:prstGeom prst="line">
            <a:avLst/>
          </a:prstGeom>
          <a:ln w="28440">
            <a:solidFill>
              <a:srgbClr val="92d05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72" name="Picture 97" descr="Twist followOS0"/>
          <p:cNvPicPr/>
          <p:nvPr/>
        </p:nvPicPr>
        <p:blipFill>
          <a:blip r:embed="rId2"/>
          <a:stretch/>
        </p:blipFill>
        <p:spPr>
          <a:xfrm>
            <a:off x="3732120" y="844560"/>
            <a:ext cx="2452680" cy="2074680"/>
          </a:xfrm>
          <a:prstGeom prst="rect">
            <a:avLst/>
          </a:prstGeom>
          <a:ln w="0">
            <a:noFill/>
          </a:ln>
        </p:spPr>
      </p:pic>
      <p:sp>
        <p:nvSpPr>
          <p:cNvPr id="73" name="Text Box 50"/>
          <p:cNvSpPr/>
          <p:nvPr/>
        </p:nvSpPr>
        <p:spPr>
          <a:xfrm>
            <a:off x="4198680" y="2284560"/>
            <a:ext cx="9334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NZ" sz="1000" spc="-1" strike="noStrike">
                <a:solidFill>
                  <a:srgbClr val="000000"/>
                </a:solidFill>
                <a:latin typeface="Arial"/>
              </a:rPr>
              <a:t>Low </a:t>
            </a:r>
            <a:r>
              <a:rPr b="1" lang="en-NZ" sz="1000" spc="-1" strike="noStrike">
                <a:solidFill>
                  <a:srgbClr val="000000"/>
                </a:solidFill>
                <a:latin typeface="Arial"/>
                <a:ea typeface="宋体"/>
              </a:rPr>
              <a:t>TWIST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Text Box 52"/>
          <p:cNvSpPr/>
          <p:nvPr/>
        </p:nvSpPr>
        <p:spPr>
          <a:xfrm>
            <a:off x="4199400" y="2441520"/>
            <a:ext cx="9612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宋体"/>
              </a:rPr>
              <a:t>High </a:t>
            </a:r>
            <a:r>
              <a:rPr b="1" lang="en-NZ" sz="1000" spc="-1" strike="noStrike">
                <a:solidFill>
                  <a:srgbClr val="000000"/>
                </a:solidFill>
                <a:latin typeface="Arial"/>
                <a:ea typeface="宋体"/>
              </a:rPr>
              <a:t>TWIST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Text Box 53"/>
          <p:cNvSpPr/>
          <p:nvPr/>
        </p:nvSpPr>
        <p:spPr>
          <a:xfrm>
            <a:off x="3982680" y="2617920"/>
            <a:ext cx="6534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000" spc="-1" strike="noStrike">
                <a:solidFill>
                  <a:srgbClr val="000000"/>
                </a:solidFill>
                <a:latin typeface="Arial"/>
                <a:ea typeface="宋体"/>
              </a:rPr>
              <a:t>P</a:t>
            </a: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宋体"/>
              </a:rPr>
              <a:t> = 0.03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Text Box 37"/>
          <p:cNvSpPr/>
          <p:nvPr/>
        </p:nvSpPr>
        <p:spPr>
          <a:xfrm>
            <a:off x="5855400" y="2592360"/>
            <a:ext cx="250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宋体"/>
              </a:rPr>
              <a:t>II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Straight Connector 223"/>
          <p:cNvSpPr/>
          <p:nvPr/>
        </p:nvSpPr>
        <p:spPr>
          <a:xfrm>
            <a:off x="4076640" y="2567160"/>
            <a:ext cx="144360" cy="0"/>
          </a:xfrm>
          <a:prstGeom prst="line">
            <a:avLst/>
          </a:prstGeom>
          <a:ln w="28440">
            <a:solidFill>
              <a:srgbClr val="4a7ebb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Straight Connector 224"/>
          <p:cNvSpPr/>
          <p:nvPr/>
        </p:nvSpPr>
        <p:spPr>
          <a:xfrm>
            <a:off x="4076640" y="2422440"/>
            <a:ext cx="144360" cy="0"/>
          </a:xfrm>
          <a:prstGeom prst="line">
            <a:avLst/>
          </a:prstGeom>
          <a:ln w="28440">
            <a:solidFill>
              <a:srgbClr val="92d05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79" name="Group 226"/>
          <p:cNvGrpSpPr/>
          <p:nvPr/>
        </p:nvGrpSpPr>
        <p:grpSpPr>
          <a:xfrm>
            <a:off x="3314880" y="285840"/>
            <a:ext cx="2922480" cy="2800440"/>
            <a:chOff x="3314880" y="285840"/>
            <a:chExt cx="2922480" cy="2800440"/>
          </a:xfrm>
        </p:grpSpPr>
        <p:sp>
          <p:nvSpPr>
            <p:cNvPr id="80" name="Text Box 5"/>
            <p:cNvSpPr/>
            <p:nvPr/>
          </p:nvSpPr>
          <p:spPr>
            <a:xfrm flipV="1">
              <a:off x="3314880" y="285840"/>
              <a:ext cx="332640" cy="2260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 vert="eaVer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NZ" sz="1000" spc="-1" strike="noStrike">
                  <a:solidFill>
                    <a:srgbClr val="000000"/>
                  </a:solidFill>
                  <a:latin typeface="Arial"/>
                </a:rPr>
                <a:t>Cumulative</a:t>
              </a: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宋体"/>
                </a:rPr>
                <a:t> survival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" name="Text Box 11"/>
            <p:cNvSpPr/>
            <p:nvPr/>
          </p:nvSpPr>
          <p:spPr>
            <a:xfrm>
              <a:off x="4189320" y="2840040"/>
              <a:ext cx="3207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宋体"/>
                </a:rPr>
                <a:t>3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" name="Text Box 12"/>
            <p:cNvSpPr/>
            <p:nvPr/>
          </p:nvSpPr>
          <p:spPr>
            <a:xfrm>
              <a:off x="4589640" y="2840040"/>
              <a:ext cx="4903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宋体"/>
                </a:rPr>
                <a:t>4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" name="Text Box 13"/>
            <p:cNvSpPr/>
            <p:nvPr/>
          </p:nvSpPr>
          <p:spPr>
            <a:xfrm>
              <a:off x="5002560" y="2835000"/>
              <a:ext cx="4996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宋体"/>
                </a:rPr>
                <a:t>5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" name="Text Box 14"/>
            <p:cNvSpPr/>
            <p:nvPr/>
          </p:nvSpPr>
          <p:spPr>
            <a:xfrm>
              <a:off x="5405760" y="2825280"/>
              <a:ext cx="4996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宋体"/>
                </a:rPr>
                <a:t>6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" name="Text Box 15"/>
            <p:cNvSpPr/>
            <p:nvPr/>
          </p:nvSpPr>
          <p:spPr>
            <a:xfrm>
              <a:off x="5808960" y="2835000"/>
              <a:ext cx="4284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宋体"/>
                </a:rPr>
                <a:t>7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" name="Text Box 16"/>
            <p:cNvSpPr/>
            <p:nvPr/>
          </p:nvSpPr>
          <p:spPr>
            <a:xfrm>
              <a:off x="3610440" y="2609280"/>
              <a:ext cx="2509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宋体"/>
                </a:rPr>
                <a:t>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" name="Text Box 17"/>
            <p:cNvSpPr/>
            <p:nvPr/>
          </p:nvSpPr>
          <p:spPr>
            <a:xfrm>
              <a:off x="3510360" y="2268360"/>
              <a:ext cx="3560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宋体"/>
                </a:rPr>
                <a:t>0.2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" name="Text Box 18"/>
            <p:cNvSpPr/>
            <p:nvPr/>
          </p:nvSpPr>
          <p:spPr>
            <a:xfrm>
              <a:off x="3504960" y="1923120"/>
              <a:ext cx="3560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宋体"/>
                </a:rPr>
                <a:t>0.4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" name="Text Box 19"/>
            <p:cNvSpPr/>
            <p:nvPr/>
          </p:nvSpPr>
          <p:spPr>
            <a:xfrm>
              <a:off x="3507840" y="1567080"/>
              <a:ext cx="3560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宋体"/>
                </a:rPr>
                <a:t>0.6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" name="Text Box 20"/>
            <p:cNvSpPr/>
            <p:nvPr/>
          </p:nvSpPr>
          <p:spPr>
            <a:xfrm>
              <a:off x="3507840" y="1226160"/>
              <a:ext cx="3560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宋体"/>
                </a:rPr>
                <a:t>0.8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" name="Text Box 21"/>
            <p:cNvSpPr/>
            <p:nvPr/>
          </p:nvSpPr>
          <p:spPr>
            <a:xfrm>
              <a:off x="3504960" y="903960"/>
              <a:ext cx="3560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宋体"/>
                </a:rPr>
                <a:t>1.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" name="Text Box 22"/>
            <p:cNvSpPr/>
            <p:nvPr/>
          </p:nvSpPr>
          <p:spPr>
            <a:xfrm>
              <a:off x="3790080" y="2830680"/>
              <a:ext cx="3207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宋体"/>
                </a:rPr>
                <a:t>2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93" name="TextBox 36"/>
          <p:cNvSpPr/>
          <p:nvPr/>
        </p:nvSpPr>
        <p:spPr>
          <a:xfrm>
            <a:off x="1643040" y="3014640"/>
            <a:ext cx="8636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NZ" sz="1000" spc="-1" strike="noStrike">
                <a:solidFill>
                  <a:srgbClr val="000000"/>
                </a:solidFill>
                <a:latin typeface="Arial"/>
                <a:ea typeface="Arial"/>
              </a:rPr>
              <a:t>Months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94" name="Picture 70" descr=""/>
          <p:cNvPicPr/>
          <p:nvPr/>
        </p:nvPicPr>
        <p:blipFill>
          <a:blip r:embed="rId3"/>
          <a:stretch/>
        </p:blipFill>
        <p:spPr>
          <a:xfrm>
            <a:off x="3735360" y="3700440"/>
            <a:ext cx="2451240" cy="2073240"/>
          </a:xfrm>
          <a:prstGeom prst="rect">
            <a:avLst/>
          </a:prstGeom>
          <a:ln w="0">
            <a:noFill/>
          </a:ln>
        </p:spPr>
      </p:pic>
      <p:sp>
        <p:nvSpPr>
          <p:cNvPr id="95" name="Text Box 73"/>
          <p:cNvSpPr/>
          <p:nvPr/>
        </p:nvSpPr>
        <p:spPr>
          <a:xfrm>
            <a:off x="4213800" y="5108400"/>
            <a:ext cx="16178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NZ" sz="1000" spc="-1" strike="noStrike">
                <a:solidFill>
                  <a:srgbClr val="000000"/>
                </a:solidFill>
                <a:latin typeface="Arial"/>
              </a:rPr>
              <a:t>Low ARTN-Low TWIST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" name="Text Box 75"/>
          <p:cNvSpPr/>
          <p:nvPr/>
        </p:nvSpPr>
        <p:spPr>
          <a:xfrm>
            <a:off x="4215240" y="5273640"/>
            <a:ext cx="16376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NZ" sz="1000" spc="-1" strike="noStrike">
                <a:solidFill>
                  <a:srgbClr val="000000"/>
                </a:solidFill>
                <a:latin typeface="Arial"/>
              </a:rPr>
              <a:t>High ARTN-HighTWIST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" name="Text Box 76"/>
          <p:cNvSpPr/>
          <p:nvPr/>
        </p:nvSpPr>
        <p:spPr>
          <a:xfrm>
            <a:off x="3976920" y="5445000"/>
            <a:ext cx="7232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000" spc="-1" strike="noStrike">
                <a:solidFill>
                  <a:srgbClr val="000000"/>
                </a:solidFill>
                <a:latin typeface="Arial"/>
                <a:ea typeface="宋体"/>
              </a:rPr>
              <a:t>P</a:t>
            </a: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宋体"/>
              </a:rPr>
              <a:t> = 0.005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" name="Text Box 37"/>
          <p:cNvSpPr/>
          <p:nvPr/>
        </p:nvSpPr>
        <p:spPr>
          <a:xfrm>
            <a:off x="5832000" y="5425920"/>
            <a:ext cx="2995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宋体"/>
              </a:rPr>
              <a:t>IV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" name="Straight Connector 246"/>
          <p:cNvSpPr/>
          <p:nvPr/>
        </p:nvSpPr>
        <p:spPr>
          <a:xfrm>
            <a:off x="4121280" y="5384880"/>
            <a:ext cx="142920" cy="0"/>
          </a:xfrm>
          <a:prstGeom prst="line">
            <a:avLst/>
          </a:prstGeom>
          <a:ln w="28440">
            <a:solidFill>
              <a:srgbClr val="4a7ebb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0" name="Straight Connector 247"/>
          <p:cNvSpPr/>
          <p:nvPr/>
        </p:nvSpPr>
        <p:spPr>
          <a:xfrm>
            <a:off x="4121280" y="5240160"/>
            <a:ext cx="142920" cy="0"/>
          </a:xfrm>
          <a:prstGeom prst="line">
            <a:avLst/>
          </a:prstGeom>
          <a:ln w="28440">
            <a:solidFill>
              <a:srgbClr val="92d05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01" name="Group 248"/>
          <p:cNvGrpSpPr/>
          <p:nvPr/>
        </p:nvGrpSpPr>
        <p:grpSpPr>
          <a:xfrm>
            <a:off x="3319560" y="3136680"/>
            <a:ext cx="2922480" cy="2800800"/>
            <a:chOff x="3319560" y="3136680"/>
            <a:chExt cx="2922480" cy="2800800"/>
          </a:xfrm>
        </p:grpSpPr>
        <p:sp>
          <p:nvSpPr>
            <p:cNvPr id="102" name="Text Box 5"/>
            <p:cNvSpPr/>
            <p:nvPr/>
          </p:nvSpPr>
          <p:spPr>
            <a:xfrm flipV="1">
              <a:off x="3319560" y="3136320"/>
              <a:ext cx="332640" cy="22604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 vert="eaVer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NZ" sz="1000" spc="-1" strike="noStrike">
                  <a:solidFill>
                    <a:srgbClr val="000000"/>
                  </a:solidFill>
                  <a:latin typeface="Arial"/>
                </a:rPr>
                <a:t>Cumulative</a:t>
              </a: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宋体"/>
                </a:rPr>
                <a:t> survival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" name="Text Box 11"/>
            <p:cNvSpPr/>
            <p:nvPr/>
          </p:nvSpPr>
          <p:spPr>
            <a:xfrm>
              <a:off x="4194000" y="5691240"/>
              <a:ext cx="3207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宋体"/>
                </a:rPr>
                <a:t>3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" name="Text Box 12"/>
            <p:cNvSpPr/>
            <p:nvPr/>
          </p:nvSpPr>
          <p:spPr>
            <a:xfrm>
              <a:off x="4594320" y="5691240"/>
              <a:ext cx="4903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宋体"/>
                </a:rPr>
                <a:t>4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" name="Text Box 13"/>
            <p:cNvSpPr/>
            <p:nvPr/>
          </p:nvSpPr>
          <p:spPr>
            <a:xfrm>
              <a:off x="5007240" y="5685840"/>
              <a:ext cx="4996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宋体"/>
                </a:rPr>
                <a:t>5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" name="Text Box 14"/>
            <p:cNvSpPr/>
            <p:nvPr/>
          </p:nvSpPr>
          <p:spPr>
            <a:xfrm>
              <a:off x="5410440" y="5676120"/>
              <a:ext cx="4996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宋体"/>
                </a:rPr>
                <a:t>6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7" name="Text Box 15"/>
            <p:cNvSpPr/>
            <p:nvPr/>
          </p:nvSpPr>
          <p:spPr>
            <a:xfrm>
              <a:off x="5813640" y="5685840"/>
              <a:ext cx="4284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宋体"/>
                </a:rPr>
                <a:t>7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8" name="Text Box 16"/>
            <p:cNvSpPr/>
            <p:nvPr/>
          </p:nvSpPr>
          <p:spPr>
            <a:xfrm>
              <a:off x="3615120" y="5460120"/>
              <a:ext cx="2509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宋体"/>
                </a:rPr>
                <a:t>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9" name="Text Box 17"/>
            <p:cNvSpPr/>
            <p:nvPr/>
          </p:nvSpPr>
          <p:spPr>
            <a:xfrm>
              <a:off x="3515040" y="5119200"/>
              <a:ext cx="3560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宋体"/>
                </a:rPr>
                <a:t>0.2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0" name="Text Box 18"/>
            <p:cNvSpPr/>
            <p:nvPr/>
          </p:nvSpPr>
          <p:spPr>
            <a:xfrm>
              <a:off x="3509640" y="4773960"/>
              <a:ext cx="3560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宋体"/>
                </a:rPr>
                <a:t>0.4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1" name="Text Box 19"/>
            <p:cNvSpPr/>
            <p:nvPr/>
          </p:nvSpPr>
          <p:spPr>
            <a:xfrm>
              <a:off x="3512520" y="4418280"/>
              <a:ext cx="3560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宋体"/>
                </a:rPr>
                <a:t>0.6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2" name="Text Box 20"/>
            <p:cNvSpPr/>
            <p:nvPr/>
          </p:nvSpPr>
          <p:spPr>
            <a:xfrm>
              <a:off x="3512520" y="4077000"/>
              <a:ext cx="3560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宋体"/>
                </a:rPr>
                <a:t>0.8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3" name="Text Box 21"/>
            <p:cNvSpPr/>
            <p:nvPr/>
          </p:nvSpPr>
          <p:spPr>
            <a:xfrm>
              <a:off x="3509640" y="3755160"/>
              <a:ext cx="3560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宋体"/>
                </a:rPr>
                <a:t>1.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4" name="Text Box 22"/>
            <p:cNvSpPr/>
            <p:nvPr/>
          </p:nvSpPr>
          <p:spPr>
            <a:xfrm>
              <a:off x="3794760" y="5681520"/>
              <a:ext cx="3207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宋体"/>
                </a:rPr>
                <a:t>2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15" name="TextBox 36"/>
          <p:cNvSpPr/>
          <p:nvPr/>
        </p:nvSpPr>
        <p:spPr>
          <a:xfrm>
            <a:off x="1652760" y="5859360"/>
            <a:ext cx="8632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NZ" sz="1000" spc="-1" strike="noStrike">
                <a:solidFill>
                  <a:srgbClr val="000000"/>
                </a:solidFill>
                <a:latin typeface="Arial"/>
                <a:ea typeface="Arial"/>
              </a:rPr>
              <a:t>Months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16" name="Group 91"/>
          <p:cNvGrpSpPr/>
          <p:nvPr/>
        </p:nvGrpSpPr>
        <p:grpSpPr>
          <a:xfrm>
            <a:off x="333360" y="3133800"/>
            <a:ext cx="2924280" cy="2800440"/>
            <a:chOff x="333360" y="3133800"/>
            <a:chExt cx="2924280" cy="2800440"/>
          </a:xfrm>
        </p:grpSpPr>
        <p:pic>
          <p:nvPicPr>
            <p:cNvPr id="117" name="Picture 92" descr=""/>
            <p:cNvPicPr/>
            <p:nvPr/>
          </p:nvPicPr>
          <p:blipFill>
            <a:blip r:embed="rId4"/>
            <a:stretch/>
          </p:blipFill>
          <p:spPr>
            <a:xfrm>
              <a:off x="774000" y="3695760"/>
              <a:ext cx="2453040" cy="20736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18" name="Text Box 95"/>
            <p:cNvSpPr/>
            <p:nvPr/>
          </p:nvSpPr>
          <p:spPr>
            <a:xfrm>
              <a:off x="1255680" y="5112000"/>
              <a:ext cx="16178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NZ" sz="1000" spc="-1" strike="noStrike">
                  <a:solidFill>
                    <a:srgbClr val="000000"/>
                  </a:solidFill>
                  <a:latin typeface="Arial"/>
                </a:rPr>
                <a:t>Low ARTN-Low TWIST1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9" name="Text Box 97"/>
            <p:cNvSpPr/>
            <p:nvPr/>
          </p:nvSpPr>
          <p:spPr>
            <a:xfrm>
              <a:off x="1252440" y="5267520"/>
              <a:ext cx="16452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NZ" sz="1000" spc="-1" strike="noStrike">
                  <a:solidFill>
                    <a:srgbClr val="000000"/>
                  </a:solidFill>
                  <a:latin typeface="Arial"/>
                </a:rPr>
                <a:t>High ARTN-Low TWIST1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0" name="Text Box 98"/>
            <p:cNvSpPr/>
            <p:nvPr/>
          </p:nvSpPr>
          <p:spPr>
            <a:xfrm>
              <a:off x="982440" y="5436000"/>
              <a:ext cx="7232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1000" spc="-1" strike="noStrike">
                  <a:solidFill>
                    <a:srgbClr val="000000"/>
                  </a:solidFill>
                  <a:latin typeface="Arial"/>
                  <a:ea typeface="宋体"/>
                </a:rPr>
                <a:t>P</a:t>
              </a: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宋体"/>
                </a:rPr>
                <a:t> = 0.004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1" name="Text Box 37"/>
            <p:cNvSpPr/>
            <p:nvPr/>
          </p:nvSpPr>
          <p:spPr>
            <a:xfrm>
              <a:off x="2848320" y="5416920"/>
              <a:ext cx="2858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宋体"/>
                </a:rPr>
                <a:t>III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2" name="Straight Connector 268"/>
            <p:cNvSpPr/>
            <p:nvPr/>
          </p:nvSpPr>
          <p:spPr>
            <a:xfrm>
              <a:off x="1152360" y="5375520"/>
              <a:ext cx="144360" cy="0"/>
            </a:xfrm>
            <a:prstGeom prst="line">
              <a:avLst/>
            </a:prstGeom>
            <a:ln w="28440">
              <a:solidFill>
                <a:srgbClr val="4a7ebb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3" name="Straight Connector 269"/>
            <p:cNvSpPr/>
            <p:nvPr/>
          </p:nvSpPr>
          <p:spPr>
            <a:xfrm>
              <a:off x="1152360" y="5231160"/>
              <a:ext cx="144360" cy="0"/>
            </a:xfrm>
            <a:prstGeom prst="line">
              <a:avLst/>
            </a:prstGeom>
            <a:ln w="28440">
              <a:solidFill>
                <a:srgbClr val="92d05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124" name="Group 270"/>
            <p:cNvGrpSpPr/>
            <p:nvPr/>
          </p:nvGrpSpPr>
          <p:grpSpPr>
            <a:xfrm>
              <a:off x="333360" y="3133800"/>
              <a:ext cx="2924280" cy="2800440"/>
              <a:chOff x="333360" y="3133800"/>
              <a:chExt cx="2924280" cy="2800440"/>
            </a:xfrm>
          </p:grpSpPr>
          <p:sp>
            <p:nvSpPr>
              <p:cNvPr id="125" name="Text Box 5"/>
              <p:cNvSpPr/>
              <p:nvPr/>
            </p:nvSpPr>
            <p:spPr>
              <a:xfrm flipV="1">
                <a:off x="333360" y="3133800"/>
                <a:ext cx="332640" cy="2260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 vert="eaVer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NZ" sz="1000" spc="-1" strike="noStrike">
                    <a:solidFill>
                      <a:srgbClr val="000000"/>
                    </a:solidFill>
                    <a:latin typeface="Arial"/>
                  </a:rPr>
                  <a:t>Cumulative</a:t>
                </a: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  <a:ea typeface="宋体"/>
                  </a:rPr>
                  <a:t> survival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6" name="Text Box 11"/>
              <p:cNvSpPr/>
              <p:nvPr/>
            </p:nvSpPr>
            <p:spPr>
              <a:xfrm>
                <a:off x="1208880" y="5688000"/>
                <a:ext cx="32076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  <a:ea typeface="宋体"/>
                  </a:rPr>
                  <a:t>30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7" name="Text Box 12"/>
              <p:cNvSpPr/>
              <p:nvPr/>
            </p:nvSpPr>
            <p:spPr>
              <a:xfrm>
                <a:off x="1608840" y="5688000"/>
                <a:ext cx="49068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  <a:ea typeface="宋体"/>
                  </a:rPr>
                  <a:t>40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8" name="Text Box 13"/>
              <p:cNvSpPr/>
              <p:nvPr/>
            </p:nvSpPr>
            <p:spPr>
              <a:xfrm>
                <a:off x="2022120" y="5682960"/>
                <a:ext cx="50004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  <a:ea typeface="宋体"/>
                  </a:rPr>
                  <a:t>50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9" name="Text Box 14"/>
              <p:cNvSpPr/>
              <p:nvPr/>
            </p:nvSpPr>
            <p:spPr>
              <a:xfrm>
                <a:off x="2425320" y="5673240"/>
                <a:ext cx="50004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  <a:ea typeface="宋体"/>
                  </a:rPr>
                  <a:t>60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0" name="Text Box 15"/>
              <p:cNvSpPr/>
              <p:nvPr/>
            </p:nvSpPr>
            <p:spPr>
              <a:xfrm>
                <a:off x="2828880" y="5682960"/>
                <a:ext cx="42876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  <a:ea typeface="宋体"/>
                  </a:rPr>
                  <a:t>70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1" name="Text Box 16"/>
              <p:cNvSpPr/>
              <p:nvPr/>
            </p:nvSpPr>
            <p:spPr>
              <a:xfrm>
                <a:off x="629640" y="5457240"/>
                <a:ext cx="25092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  <a:ea typeface="宋体"/>
                  </a:rPr>
                  <a:t>0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2" name="Text Box 17"/>
              <p:cNvSpPr/>
              <p:nvPr/>
            </p:nvSpPr>
            <p:spPr>
              <a:xfrm>
                <a:off x="529200" y="5116320"/>
                <a:ext cx="35604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  <a:ea typeface="宋体"/>
                  </a:rPr>
                  <a:t>0.2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3" name="Text Box 18"/>
              <p:cNvSpPr/>
              <p:nvPr/>
            </p:nvSpPr>
            <p:spPr>
              <a:xfrm>
                <a:off x="524160" y="4771080"/>
                <a:ext cx="35604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  <a:ea typeface="宋体"/>
                  </a:rPr>
                  <a:t>0.4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4" name="Text Box 19"/>
              <p:cNvSpPr/>
              <p:nvPr/>
            </p:nvSpPr>
            <p:spPr>
              <a:xfrm>
                <a:off x="526680" y="4415040"/>
                <a:ext cx="35604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  <a:ea typeface="宋体"/>
                  </a:rPr>
                  <a:t>0.6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5" name="Text Box 20"/>
              <p:cNvSpPr/>
              <p:nvPr/>
            </p:nvSpPr>
            <p:spPr>
              <a:xfrm>
                <a:off x="526680" y="4074120"/>
                <a:ext cx="35604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  <a:ea typeface="宋体"/>
                  </a:rPr>
                  <a:t>0.8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6" name="Text Box 21"/>
              <p:cNvSpPr/>
              <p:nvPr/>
            </p:nvSpPr>
            <p:spPr>
              <a:xfrm>
                <a:off x="524160" y="3751920"/>
                <a:ext cx="35604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  <a:ea typeface="宋体"/>
                  </a:rPr>
                  <a:t>1.0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7" name="Text Box 22"/>
              <p:cNvSpPr/>
              <p:nvPr/>
            </p:nvSpPr>
            <p:spPr>
              <a:xfrm>
                <a:off x="809280" y="5678640"/>
                <a:ext cx="32076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  <a:ea typeface="宋体"/>
                  </a:rPr>
                  <a:t>20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</p:grpSp>
      <p:sp>
        <p:nvSpPr>
          <p:cNvPr id="138" name="TextBox 36"/>
          <p:cNvSpPr/>
          <p:nvPr/>
        </p:nvSpPr>
        <p:spPr>
          <a:xfrm>
            <a:off x="4622760" y="5861160"/>
            <a:ext cx="8636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NZ" sz="1000" spc="-1" strike="noStrike">
                <a:solidFill>
                  <a:srgbClr val="000000"/>
                </a:solidFill>
                <a:latin typeface="Arial"/>
                <a:ea typeface="Arial"/>
              </a:rPr>
              <a:t>Months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9778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0-05-06T23:04:05Z</dcterms:created>
  <dc:creator>Uni User</dc:creator>
  <dc:description/>
  <dc:language>en-US</dc:language>
  <cp:lastModifiedBy>arunima</cp:lastModifiedBy>
  <dcterms:modified xsi:type="dcterms:W3CDTF">2011-11-22T05:57:13Z</dcterms:modified>
  <cp:revision>1056</cp:revision>
  <dc:subject/>
  <dc:title>Slide 1</dc:title>
</cp:coreProperties>
</file>